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434F33-A679-4CF7-98C3-172E67B166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692E6-5C9F-4EDE-9289-2C2261FAAB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9C16F6-7651-4112-8C45-F0FAC5709E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7F985-5E83-45D7-830C-1824C16F6D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4541B3-CD0B-4000-B6EF-37C3EC56DD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729CA1-1757-4D4A-BBDA-4FE1B0FF7C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6CD571-6640-42E8-BF18-B61CECD8BB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0B67B9-A808-48B5-BE42-265FB4865A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A357E1-232B-40C2-A638-B44587575B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0CB8D6-B2B4-4725-B8F8-6A449820D6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A6211-0B99-4904-A24D-B162D71E29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C39F8-9832-4DA1-AB26-4780C1E52C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1C4DE0-230B-4CDB-BCF9-20E77033FDD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960" y="0"/>
            <a:ext cx="2690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S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2001960" y="3513240"/>
            <a:ext cx="2917440" cy="115920"/>
            <a:chOff x="2001960" y="3513240"/>
            <a:chExt cx="2917440" cy="115920"/>
          </a:xfrm>
        </p:grpSpPr>
        <p:sp>
          <p:nvSpPr>
            <p:cNvPr id="43" name=""/>
            <p:cNvSpPr/>
            <p:nvPr/>
          </p:nvSpPr>
          <p:spPr>
            <a:xfrm>
              <a:off x="2001960" y="3513240"/>
              <a:ext cx="49680" cy="115920"/>
            </a:xfrm>
            <a:prstGeom prst="rect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048040" y="3513240"/>
              <a:ext cx="2871360" cy="115920"/>
            </a:xfrm>
            <a:prstGeom prst="rect">
              <a:avLst/>
            </a:prstGeom>
            <a:solidFill>
              <a:srgbClr val="99ff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" name=""/>
          <p:cNvSpPr/>
          <p:nvPr/>
        </p:nvSpPr>
        <p:spPr>
          <a:xfrm flipV="1" rot="16200000">
            <a:off x="1942560" y="3691800"/>
            <a:ext cx="142560" cy="71280"/>
          </a:xfrm>
          <a:custGeom>
            <a:avLst/>
            <a:gdLst>
              <a:gd name="textAreaLeft" fmla="*/ 91080 w 142560"/>
              <a:gd name="textAreaRight" fmla="*/ 142920 w 142560"/>
              <a:gd name="textAreaTop" fmla="*/ 1800 h 71280"/>
              <a:gd name="textAreaBottom" fmla="*/ 69480 h 712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880" bIns="20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554120" y="3733920"/>
            <a:ext cx="64944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 Mincho"/>
              </a:rPr>
              <a:t>16 a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312920" y="3149640"/>
            <a:ext cx="220680" cy="11592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533600" y="3149640"/>
            <a:ext cx="520560" cy="115920"/>
          </a:xfrm>
          <a:prstGeom prst="rect">
            <a:avLst/>
          </a:prstGeom>
          <a:solidFill>
            <a:srgbClr val="ff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054160" y="3149640"/>
            <a:ext cx="2871720" cy="115920"/>
          </a:xfrm>
          <a:prstGeom prst="rect">
            <a:avLst/>
          </a:prstGeom>
          <a:solidFill>
            <a:srgbClr val="99ff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5400000">
            <a:off x="1625400" y="2676240"/>
            <a:ext cx="120600" cy="727200"/>
          </a:xfrm>
          <a:custGeom>
            <a:avLst/>
            <a:gdLst>
              <a:gd name="textAreaLeft" fmla="*/ 77040 w 120600"/>
              <a:gd name="textAreaRight" fmla="*/ 120960 w 120600"/>
              <a:gd name="textAreaTop" fmla="*/ 18720 h 727200"/>
              <a:gd name="textAreaBottom" fmla="*/ 708480 h 727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V="1" rot="16200000">
            <a:off x="1825200" y="4109400"/>
            <a:ext cx="120600" cy="228600"/>
          </a:xfrm>
          <a:custGeom>
            <a:avLst/>
            <a:gdLst>
              <a:gd name="textAreaLeft" fmla="*/ 77040 w 120600"/>
              <a:gd name="textAreaRight" fmla="*/ 120960 w 120600"/>
              <a:gd name="textAreaTop" fmla="*/ 5760 h 228600"/>
              <a:gd name="textAreaBottom" fmla="*/ 222840 h 2286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57200" y="3325680"/>
            <a:ext cx="914400" cy="49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 Mincho"/>
              </a:rPr>
              <a:t>Hydrophobi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V="1">
            <a:off x="1117440" y="3267000"/>
            <a:ext cx="171720" cy="108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509840" y="4237200"/>
            <a:ext cx="53316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 Mincho"/>
              </a:rPr>
              <a:t>114 a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477800" y="2819520"/>
            <a:ext cx="57960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 Mincho"/>
              </a:rPr>
              <a:t>218 a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240000" y="2819520"/>
            <a:ext cx="73656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 Mincho"/>
              </a:rPr>
              <a:t>~2200 a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5400000">
            <a:off x="3434400" y="1622880"/>
            <a:ext cx="128520" cy="2826000"/>
          </a:xfrm>
          <a:custGeom>
            <a:avLst/>
            <a:gdLst>
              <a:gd name="textAreaLeft" fmla="*/ 82080 w 128520"/>
              <a:gd name="textAreaRight" fmla="*/ 128880 w 128520"/>
              <a:gd name="textAreaTop" fmla="*/ 73440 h 2826000"/>
              <a:gd name="textAreaBottom" fmla="*/ 2752560 h 2826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184720" y="3056040"/>
            <a:ext cx="12128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ACC2.v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5176800" y="3435480"/>
            <a:ext cx="10414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ACC2.v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049480" y="3973680"/>
            <a:ext cx="2871720" cy="114120"/>
          </a:xfrm>
          <a:prstGeom prst="rect">
            <a:avLst/>
          </a:prstGeom>
          <a:solidFill>
            <a:srgbClr val="99ff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187960" y="3838680"/>
            <a:ext cx="12128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ACC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164040" y="3973680"/>
            <a:ext cx="247320" cy="114120"/>
          </a:xfrm>
          <a:prstGeom prst="rect">
            <a:avLst/>
          </a:prstGeom>
          <a:solidFill>
            <a:srgbClr val="99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981600" y="3973680"/>
            <a:ext cx="944280" cy="1141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981600" y="3149640"/>
            <a:ext cx="944280" cy="115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981600" y="3513240"/>
            <a:ext cx="949320" cy="115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164040" y="3152880"/>
            <a:ext cx="247320" cy="112680"/>
          </a:xfrm>
          <a:prstGeom prst="rect">
            <a:avLst/>
          </a:prstGeom>
          <a:solidFill>
            <a:srgbClr val="99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164040" y="3513240"/>
            <a:ext cx="247320" cy="115920"/>
          </a:xfrm>
          <a:prstGeom prst="rect">
            <a:avLst/>
          </a:prstGeom>
          <a:solidFill>
            <a:srgbClr val="99cc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4403880" y="3784320"/>
            <a:ext cx="128520" cy="887400"/>
          </a:xfrm>
          <a:custGeom>
            <a:avLst/>
            <a:gdLst>
              <a:gd name="textAreaLeft" fmla="*/ 82080 w 128520"/>
              <a:gd name="textAreaRight" fmla="*/ 128880 w 128520"/>
              <a:gd name="textAreaTop" fmla="*/ 23040 h 887400"/>
              <a:gd name="textAreaBottom" fmla="*/ 864360 h 8874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16200000">
            <a:off x="3224880" y="4105800"/>
            <a:ext cx="120600" cy="236520"/>
          </a:xfrm>
          <a:custGeom>
            <a:avLst/>
            <a:gdLst>
              <a:gd name="textAreaLeft" fmla="*/ 77040 w 120600"/>
              <a:gd name="textAreaRight" fmla="*/ 120960 w 120600"/>
              <a:gd name="textAreaTop" fmla="*/ 6120 h 236520"/>
              <a:gd name="textAreaBottom" fmla="*/ 230400 h 236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rot="16200000">
            <a:off x="2522520" y="3688920"/>
            <a:ext cx="128520" cy="1077840"/>
          </a:xfrm>
          <a:custGeom>
            <a:avLst/>
            <a:gdLst>
              <a:gd name="textAreaLeft" fmla="*/ 82080 w 128520"/>
              <a:gd name="textAreaRight" fmla="*/ 128880 w 128520"/>
              <a:gd name="textAreaTop" fmla="*/ 28080 h 1077840"/>
              <a:gd name="textAreaBottom" fmla="*/ 1049760 h 10778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297320" y="4329000"/>
            <a:ext cx="1325520" cy="1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 Mincho"/>
              </a:rPr>
              <a:t>Carboxyltransferas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920960" y="4329000"/>
            <a:ext cx="1168200" cy="23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 Mincho"/>
              </a:rPr>
              <a:t>Biotin carboxyla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062160" y="4329000"/>
            <a:ext cx="1386000" cy="1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 Mincho"/>
              </a:rPr>
              <a:t>Biotin carboxyl carrie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755720" y="3973680"/>
            <a:ext cx="292320" cy="11412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411360" y="3513240"/>
            <a:ext cx="570240" cy="1159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411360" y="3973680"/>
            <a:ext cx="570240" cy="1141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411360" y="3152880"/>
            <a:ext cx="570240" cy="1141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17T16:39:31Z</dcterms:created>
  <dc:creator>John Castle</dc:creator>
  <dc:description/>
  <dc:language>en-US</dc:language>
  <cp:lastModifiedBy>Merck</cp:lastModifiedBy>
  <dcterms:modified xsi:type="dcterms:W3CDTF">2008-07-10T05:04:43Z</dcterms:modified>
  <cp:revision>11</cp:revision>
  <dc:subject/>
  <dc:title>Slide 1</dc:title>
</cp:coreProperties>
</file>